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780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87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531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128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906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53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86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79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723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624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152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16F41-BC0E-428A-8AEE-B09B339021D5}" type="datetimeFigureOut">
              <a:rPr lang="en-US" smtClean="0"/>
              <a:t>8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92AE7-87E3-44F6-904B-8EB34C3E3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605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charset="0"/>
                <a:ea typeface="ＭＳ Ｐゴシック" charset="0"/>
                <a:cs typeface="ＭＳ Ｐゴシック" charset="0"/>
              </a:rPr>
              <a:t>Supplemental Table 1</a:t>
            </a:r>
            <a:endParaRPr lang="en-US" dirty="0"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7178774"/>
              </p:ext>
            </p:extLst>
          </p:nvPr>
        </p:nvGraphicFramePr>
        <p:xfrm>
          <a:off x="553960" y="1600198"/>
          <a:ext cx="8036079" cy="4525968"/>
        </p:xfrm>
        <a:graphic>
          <a:graphicData uri="http://schemas.openxmlformats.org/drawingml/2006/table">
            <a:tbl>
              <a:tblPr/>
              <a:tblGrid>
                <a:gridCol w="680255"/>
                <a:gridCol w="680255"/>
                <a:gridCol w="698395"/>
                <a:gridCol w="680255"/>
                <a:gridCol w="680255"/>
                <a:gridCol w="680255"/>
                <a:gridCol w="680255"/>
                <a:gridCol w="680255"/>
                <a:gridCol w="680255"/>
                <a:gridCol w="680255"/>
                <a:gridCol w="680255"/>
                <a:gridCol w="535134"/>
              </a:tblGrid>
              <a:tr h="3537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reREP TIL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ercent of CD3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effectLst/>
                          <a:latin typeface="Verdana"/>
                        </a:rPr>
                        <a:t>Percent of CD4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ercent of CD4+ CD25+ FoxP3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ercent of CD3+ CD4+ CD25+ FoxP3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Week Analyzed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69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atient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6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D-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4-1BB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GITR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69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5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6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4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1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2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5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6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0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5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0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9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3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.4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.6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73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6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5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029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7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5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0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3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0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5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Verdana"/>
                        </a:rPr>
                        <a:t>36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73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9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98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0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.7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0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094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9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40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6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4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2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6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53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2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45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4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8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0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3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3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0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24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2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2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effectLst/>
                          <a:latin typeface="Verdana"/>
                        </a:rPr>
                        <a:t>0.59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.6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99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0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1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5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4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3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7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6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46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08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3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5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5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2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6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8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35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0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80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4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9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3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34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92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0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.8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23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5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4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9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4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3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5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.3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02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6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5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8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3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3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37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8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7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1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7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6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3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90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8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.10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9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0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1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9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9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3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8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7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34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58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ercent of CD3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ercent of CD8+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Week Analyzed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69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atient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6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CD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PD-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4-1BB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GITR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69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0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9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2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2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4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8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.7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8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8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4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5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6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1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7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3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.0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1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3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9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0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.6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FF0000"/>
                          </a:solidFill>
                          <a:effectLst/>
                          <a:latin typeface="Verdana"/>
                        </a:rPr>
                        <a:t>4.9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3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1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9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7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.4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11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0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92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9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2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.8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9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3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6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.7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8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0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44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0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6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7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8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0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8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5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14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3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2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.9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8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3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9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7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.4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4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7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8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1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64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.1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1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5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2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6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1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6.9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9.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.0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.0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.2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6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9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8.0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6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17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8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28.7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49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6.1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2.8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.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40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effectLst/>
                        <a:latin typeface="Verdana"/>
                      </a:endParaRP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69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9</a:t>
                      </a:r>
                    </a:p>
                  </a:txBody>
                  <a:tcPr marL="9070" marR="9070" marT="907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9.0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0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71.4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10.6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59.2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0.235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effectLst/>
                          <a:latin typeface="Verdana"/>
                        </a:rPr>
                        <a:t> 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9070" marR="9070" marT="907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68068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latin typeface="Calibri" charset="0"/>
                <a:ea typeface="ＭＳ Ｐゴシック" charset="0"/>
                <a:cs typeface="ＭＳ Ｐゴシック" charset="0"/>
              </a:rPr>
              <a:t>Supplemental Table </a:t>
            </a:r>
            <a:r>
              <a:rPr lang="en-US" dirty="0">
                <a:latin typeface="Calibri" charset="0"/>
                <a:ea typeface="ＭＳ Ｐゴシック" charset="0"/>
                <a:cs typeface="ＭＳ Ｐゴシック" charset="0"/>
              </a:rPr>
              <a:t>2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2703765"/>
              </p:ext>
            </p:extLst>
          </p:nvPr>
        </p:nvGraphicFramePr>
        <p:xfrm>
          <a:off x="801077" y="2085179"/>
          <a:ext cx="7463693" cy="1500128"/>
        </p:xfrm>
        <a:graphic>
          <a:graphicData uri="http://schemas.openxmlformats.org/drawingml/2006/table">
            <a:tbl>
              <a:tblPr/>
              <a:tblGrid>
                <a:gridCol w="1251674"/>
                <a:gridCol w="1135780"/>
                <a:gridCol w="1135780"/>
                <a:gridCol w="1135780"/>
                <a:gridCol w="1274854"/>
                <a:gridCol w="1529825"/>
              </a:tblGrid>
              <a:tr h="33979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effectLst/>
                          <a:latin typeface="Verdana"/>
                        </a:rPr>
                        <a:t>Patient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effectLst/>
                          <a:latin typeface="Verdana"/>
                        </a:rPr>
                        <a:t>CD4 </a:t>
                      </a:r>
                      <a:r>
                        <a:rPr lang="en-US" sz="1000" b="1" i="0" u="none" strike="noStrike" dirty="0" err="1">
                          <a:effectLst/>
                          <a:latin typeface="Verdana"/>
                        </a:rPr>
                        <a:t>PreREP</a:t>
                      </a:r>
                      <a:endParaRPr lang="en-US" sz="1000" b="1" i="0" u="none" strike="noStrike" dirty="0">
                        <a:effectLst/>
                        <a:latin typeface="Verdan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CD4 PostRE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CD8 PreRE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CD8 PostRE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REP Fold Expansion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060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2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96.9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95.7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1.9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3.1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80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189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3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95.4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95.9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4.0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3.7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13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18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4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61.4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81.1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35.1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17.3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77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2711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Mean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84.6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90.9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13.7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Verdana"/>
                        </a:rPr>
                        <a:t>8.0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effectLst/>
                          <a:latin typeface="Verdana"/>
                        </a:rPr>
                        <a:t>96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77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effectLst/>
                          <a:latin typeface="Verdana"/>
                        </a:rPr>
                        <a:t>SD</a:t>
                      </a: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Verdana"/>
                        </a:rPr>
                        <a:t>20.1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8.5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18.6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Verdana"/>
                        </a:rPr>
                        <a:t>8.0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effectLst/>
                          <a:latin typeface="Verdana"/>
                        </a:rPr>
                        <a:t>300</a:t>
                      </a:r>
                      <a:endParaRPr lang="en-US" sz="1000" b="0" i="0" u="none" strike="noStrike" dirty="0">
                        <a:effectLst/>
                        <a:latin typeface="Verdana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4878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697" name="Group 7"/>
          <p:cNvGrpSpPr>
            <a:grpSpLocks/>
          </p:cNvGrpSpPr>
          <p:nvPr/>
        </p:nvGrpSpPr>
        <p:grpSpPr bwMode="auto">
          <a:xfrm>
            <a:off x="2514600" y="1368425"/>
            <a:ext cx="4529138" cy="4991100"/>
            <a:chOff x="2514626" y="1367692"/>
            <a:chExt cx="4528992" cy="4991406"/>
          </a:xfrm>
        </p:grpSpPr>
        <p:pic>
          <p:nvPicPr>
            <p:cNvPr id="29699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4626" y="1367692"/>
              <a:ext cx="4528992" cy="4835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9700" name="TextBox 4"/>
            <p:cNvSpPr txBox="1">
              <a:spLocks noChangeArrowheads="1"/>
            </p:cNvSpPr>
            <p:nvPr/>
          </p:nvSpPr>
          <p:spPr bwMode="auto">
            <a:xfrm>
              <a:off x="3330330" y="6020544"/>
              <a:ext cx="1506943" cy="33855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1600" b="1">
                  <a:cs typeface="Arial" charset="0"/>
                </a:rPr>
                <a:t>HLA-Matched</a:t>
              </a:r>
            </a:p>
          </p:txBody>
        </p:sp>
        <p:sp>
          <p:nvSpPr>
            <p:cNvPr id="29701" name="TextBox 17"/>
            <p:cNvSpPr txBox="1">
              <a:spLocks noChangeArrowheads="1"/>
            </p:cNvSpPr>
            <p:nvPr/>
          </p:nvSpPr>
          <p:spPr bwMode="auto">
            <a:xfrm>
              <a:off x="4973518" y="6014646"/>
              <a:ext cx="1860505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1600" b="1">
                  <a:cs typeface="Arial" charset="0"/>
                </a:rPr>
                <a:t>HLA-Mismatched</a:t>
              </a:r>
            </a:p>
          </p:txBody>
        </p:sp>
      </p:grpSp>
      <p:sp>
        <p:nvSpPr>
          <p:cNvPr id="29698" name="Title 1"/>
          <p:cNvSpPr>
            <a:spLocks noGrp="1"/>
          </p:cNvSpPr>
          <p:nvPr>
            <p:ph type="title"/>
          </p:nvPr>
        </p:nvSpPr>
        <p:spPr>
          <a:xfrm>
            <a:off x="457200" y="30163"/>
            <a:ext cx="8229600" cy="1143000"/>
          </a:xfrm>
        </p:spPr>
        <p:txBody>
          <a:bodyPr/>
          <a:lstStyle/>
          <a:p>
            <a:r>
              <a:rPr lang="en-US" dirty="0" smtClean="0">
                <a:latin typeface="Calibri" charset="0"/>
                <a:ea typeface="ＭＳ Ｐゴシック" charset="0"/>
                <a:cs typeface="ＭＳ Ｐゴシック" charset="0"/>
              </a:rPr>
              <a:t>Supplemental </a:t>
            </a:r>
            <a:r>
              <a:rPr lang="en-US" dirty="0">
                <a:latin typeface="Calibri" charset="0"/>
                <a:ea typeface="ＭＳ Ｐゴシック" charset="0"/>
                <a:cs typeface="ＭＳ Ｐゴシック" charset="0"/>
              </a:rPr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280290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9451" y="2093540"/>
            <a:ext cx="3735756" cy="318800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99763" y="2093540"/>
            <a:ext cx="3735756" cy="3231090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457200" y="30163"/>
            <a:ext cx="8229600" cy="1143000"/>
          </a:xfrm>
        </p:spPr>
        <p:txBody>
          <a:bodyPr/>
          <a:lstStyle/>
          <a:p>
            <a:r>
              <a:rPr lang="en-US" smtClean="0">
                <a:latin typeface="Calibri" charset="0"/>
                <a:ea typeface="ＭＳ Ｐゴシック" charset="0"/>
                <a:cs typeface="ＭＳ Ｐゴシック" charset="0"/>
              </a:rPr>
              <a:t>Supplemental </a:t>
            </a:r>
            <a:r>
              <a:rPr lang="en-US" dirty="0">
                <a:latin typeface="Calibri" charset="0"/>
                <a:ea typeface="ＭＳ Ｐゴシック" charset="0"/>
                <a:cs typeface="ＭＳ Ｐゴシック" charset="0"/>
              </a:rPr>
              <a:t>Figure </a:t>
            </a:r>
            <a:r>
              <a:rPr lang="en-US" dirty="0" smtClean="0">
                <a:latin typeface="Calibri" charset="0"/>
                <a:ea typeface="ＭＳ Ｐゴシック" charset="0"/>
                <a:cs typeface="ＭＳ Ｐゴシック" charset="0"/>
              </a:rPr>
              <a:t>2</a:t>
            </a:r>
            <a:endParaRPr lang="en-US" dirty="0"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TextBox 19"/>
          <p:cNvSpPr txBox="1">
            <a:spLocks noChangeArrowheads="1"/>
          </p:cNvSpPr>
          <p:nvPr/>
        </p:nvSpPr>
        <p:spPr bwMode="auto">
          <a:xfrm>
            <a:off x="457200" y="1796135"/>
            <a:ext cx="3492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800" b="1" dirty="0"/>
              <a:t>A</a:t>
            </a:r>
          </a:p>
        </p:txBody>
      </p:sp>
      <p:sp>
        <p:nvSpPr>
          <p:cNvPr id="9" name="TextBox 19"/>
          <p:cNvSpPr txBox="1">
            <a:spLocks noChangeArrowheads="1"/>
          </p:cNvSpPr>
          <p:nvPr/>
        </p:nvSpPr>
        <p:spPr bwMode="auto">
          <a:xfrm>
            <a:off x="4677512" y="1796134"/>
            <a:ext cx="3492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8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28897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0</Words>
  <Application>Microsoft Office PowerPoint</Application>
  <PresentationFormat>On-screen Show (4:3)</PresentationFormat>
  <Paragraphs>40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upplemental Table 1</vt:lpstr>
      <vt:lpstr>Supplemental Table 2</vt:lpstr>
      <vt:lpstr>Supplemental Figure 1</vt:lpstr>
      <vt:lpstr>Supplemental Figure 2</vt:lpstr>
    </vt:vector>
  </TitlesOfParts>
  <Company>Moffitt Cancer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 1</dc:title>
  <dc:creator>Pilon-Thomas, Shari A.</dc:creator>
  <cp:lastModifiedBy>Pilon-Thomas, Shari A.</cp:lastModifiedBy>
  <cp:revision>1</cp:revision>
  <dcterms:created xsi:type="dcterms:W3CDTF">2016-08-19T21:07:21Z</dcterms:created>
  <dcterms:modified xsi:type="dcterms:W3CDTF">2016-08-19T21:07:49Z</dcterms:modified>
</cp:coreProperties>
</file>